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7" r:id="rId5"/>
    <p:sldId id="268" r:id="rId6"/>
    <p:sldId id="269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0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527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683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636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511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720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99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340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670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968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63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299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8039FB-2DE6-4EBE-BD59-1018154D66F1}" type="datetimeFigureOut">
              <a:rPr lang="en-US" smtClean="0"/>
              <a:t>7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0DA55-7225-4C86-ACCC-BF35FB729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92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609600" y="468868"/>
            <a:ext cx="7456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     SGT Antisense RNA construct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1143000" y="1204496"/>
            <a:ext cx="7086600" cy="852904"/>
            <a:chOff x="533400" y="1052096"/>
            <a:chExt cx="7086600" cy="852904"/>
          </a:xfrm>
        </p:grpSpPr>
        <p:grpSp>
          <p:nvGrpSpPr>
            <p:cNvPr id="2" name="Group 1"/>
            <p:cNvGrpSpPr/>
            <p:nvPr/>
          </p:nvGrpSpPr>
          <p:grpSpPr>
            <a:xfrm>
              <a:off x="1066676" y="1608756"/>
              <a:ext cx="6553324" cy="296244"/>
              <a:chOff x="640123" y="1488309"/>
              <a:chExt cx="6553324" cy="296244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640123" y="1488309"/>
                <a:ext cx="4341447" cy="294789"/>
                <a:chOff x="1095110" y="1488309"/>
                <a:chExt cx="4341447" cy="294789"/>
              </a:xfrm>
            </p:grpSpPr>
            <p:sp>
              <p:nvSpPr>
                <p:cNvPr id="16" name="Rectangle 15"/>
                <p:cNvSpPr/>
                <p:nvPr/>
              </p:nvSpPr>
              <p:spPr>
                <a:xfrm>
                  <a:off x="1095110" y="1525312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7" name="Rounded Rectangle 16"/>
                <p:cNvSpPr/>
                <p:nvPr/>
              </p:nvSpPr>
              <p:spPr>
                <a:xfrm>
                  <a:off x="1484209" y="1525311"/>
                  <a:ext cx="365760" cy="228600"/>
                </a:xfrm>
                <a:prstGeom prst="roundRect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" name="Rectangle 17"/>
                <p:cNvSpPr/>
                <p:nvPr/>
              </p:nvSpPr>
              <p:spPr>
                <a:xfrm>
                  <a:off x="2442828" y="1528034"/>
                  <a:ext cx="1097280" cy="228600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>
                  <a:solidFill>
                    <a:schemeClr val="accent4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Right Arrow 18"/>
                <p:cNvSpPr/>
                <p:nvPr/>
              </p:nvSpPr>
              <p:spPr>
                <a:xfrm flipH="1">
                  <a:off x="3561474" y="1528237"/>
                  <a:ext cx="457200" cy="228600"/>
                </a:xfrm>
                <a:prstGeom prst="rightArrow">
                  <a:avLst/>
                </a:prstGeom>
                <a:solidFill>
                  <a:schemeClr val="bg2">
                    <a:lumMod val="50000"/>
                  </a:schemeClr>
                </a:solidFill>
                <a:ln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Right Arrow 19"/>
                <p:cNvSpPr/>
                <p:nvPr/>
              </p:nvSpPr>
              <p:spPr>
                <a:xfrm rot="10800000" flipH="1">
                  <a:off x="4705037" y="1525311"/>
                  <a:ext cx="731520" cy="228600"/>
                </a:xfrm>
                <a:prstGeom prst="rightArrow">
                  <a:avLst/>
                </a:prstGeom>
                <a:solidFill>
                  <a:srgbClr val="97517B"/>
                </a:solidFill>
                <a:ln>
                  <a:solidFill>
                    <a:srgbClr val="97517B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095110" y="1506099"/>
                  <a:ext cx="3898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B</a:t>
                  </a:r>
                </a:p>
              </p:txBody>
            </p:sp>
            <p:cxnSp>
              <p:nvCxnSpPr>
                <p:cNvPr id="22" name="Straight Connector 21"/>
                <p:cNvCxnSpPr/>
                <p:nvPr/>
              </p:nvCxnSpPr>
              <p:spPr>
                <a:xfrm>
                  <a:off x="4393138" y="1644110"/>
                  <a:ext cx="297269" cy="0"/>
                </a:xfrm>
                <a:prstGeom prst="line">
                  <a:avLst/>
                </a:prstGeom>
              </p:spPr>
              <p:style>
                <a:lnRef idx="3">
                  <a:schemeClr val="accent2"/>
                </a:lnRef>
                <a:fillRef idx="0">
                  <a:schemeClr val="accent2"/>
                </a:fillRef>
                <a:effectRef idx="2">
                  <a:schemeClr val="accent2"/>
                </a:effectRef>
                <a:fontRef idx="minor">
                  <a:schemeClr val="tx1"/>
                </a:fontRef>
              </p:style>
            </p:cxnSp>
            <p:sp>
              <p:nvSpPr>
                <p:cNvPr id="23" name="TextBox 22"/>
                <p:cNvSpPr txBox="1"/>
                <p:nvPr/>
              </p:nvSpPr>
              <p:spPr>
                <a:xfrm>
                  <a:off x="1441410" y="1502212"/>
                  <a:ext cx="4764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oxP</a:t>
                  </a:r>
                </a:p>
              </p:txBody>
            </p:sp>
            <p:sp>
              <p:nvSpPr>
                <p:cNvPr id="24" name="Rectangle 23"/>
                <p:cNvSpPr/>
                <p:nvPr/>
              </p:nvSpPr>
              <p:spPr>
                <a:xfrm>
                  <a:off x="1872325" y="1522396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1857935" y="1488309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2800341" y="1496371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r</a:t>
                  </a: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3634067" y="1506099"/>
                  <a:ext cx="42351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S</a:t>
                  </a:r>
                </a:p>
              </p:txBody>
            </p:sp>
            <p:sp>
              <p:nvSpPr>
                <p:cNvPr id="28" name="Rounded Rectangle 27"/>
                <p:cNvSpPr/>
                <p:nvPr/>
              </p:nvSpPr>
              <p:spPr>
                <a:xfrm>
                  <a:off x="4027378" y="1528237"/>
                  <a:ext cx="365760" cy="228600"/>
                </a:xfrm>
                <a:prstGeom prst="roundRect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solidFill>
                    <a:schemeClr val="accent5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992137" y="1504894"/>
                  <a:ext cx="47641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oxP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815629" y="1505896"/>
                  <a:ext cx="5180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apin</a:t>
                  </a:r>
                  <a:endPara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" name="Group 3"/>
              <p:cNvGrpSpPr/>
              <p:nvPr/>
            </p:nvGrpSpPr>
            <p:grpSpPr>
              <a:xfrm>
                <a:off x="6238855" y="1489528"/>
                <a:ext cx="954592" cy="295025"/>
                <a:chOff x="6799023" y="1499053"/>
                <a:chExt cx="954592" cy="295025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6799023" y="1528237"/>
                  <a:ext cx="925516" cy="228600"/>
                  <a:chOff x="6783784" y="1528237"/>
                  <a:chExt cx="925516" cy="228600"/>
                </a:xfrm>
              </p:grpSpPr>
              <p:sp>
                <p:nvSpPr>
                  <p:cNvPr id="14" name="Rectangle 13"/>
                  <p:cNvSpPr/>
                  <p:nvPr/>
                </p:nvSpPr>
                <p:spPr>
                  <a:xfrm>
                    <a:off x="6783784" y="1528237"/>
                    <a:ext cx="548640" cy="228600"/>
                  </a:xfrm>
                  <a:prstGeom prst="rect">
                    <a:avLst/>
                  </a:prstGeom>
                  <a:solidFill>
                    <a:schemeClr val="accent3">
                      <a:lumMod val="40000"/>
                      <a:lumOff val="60000"/>
                    </a:schemeClr>
                  </a:solidFill>
                  <a:ln>
                    <a:solidFill>
                      <a:schemeClr val="accent3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5" name="Rectangle 14"/>
                  <p:cNvSpPr/>
                  <p:nvPr/>
                </p:nvSpPr>
                <p:spPr>
                  <a:xfrm>
                    <a:off x="7343540" y="1528237"/>
                    <a:ext cx="365760" cy="228600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solidFill>
                      <a:schemeClr val="accent6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grpSp>
              <p:nvGrpSpPr>
                <p:cNvPr id="11" name="Group 10"/>
                <p:cNvGrpSpPr/>
                <p:nvPr/>
              </p:nvGrpSpPr>
              <p:grpSpPr>
                <a:xfrm>
                  <a:off x="6819875" y="1499053"/>
                  <a:ext cx="933740" cy="295025"/>
                  <a:chOff x="6766536" y="1499053"/>
                  <a:chExt cx="933740" cy="295025"/>
                </a:xfrm>
              </p:grpSpPr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6766536" y="1499053"/>
                    <a:ext cx="585417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cspA</a:t>
                    </a:r>
                    <a:endPara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7302410" y="1517079"/>
                    <a:ext cx="39786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B</a:t>
                    </a:r>
                  </a:p>
                </p:txBody>
              </p:sp>
            </p:grpSp>
          </p:grpSp>
          <p:sp>
            <p:nvSpPr>
              <p:cNvPr id="5" name="Right Arrow 4"/>
              <p:cNvSpPr/>
              <p:nvPr/>
            </p:nvSpPr>
            <p:spPr>
              <a:xfrm flipH="1">
                <a:off x="5492104" y="1726321"/>
                <a:ext cx="108680" cy="4571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6" name="Group 5"/>
              <p:cNvGrpSpPr/>
              <p:nvPr/>
            </p:nvGrpSpPr>
            <p:grpSpPr>
              <a:xfrm>
                <a:off x="5013956" y="1522117"/>
                <a:ext cx="1196040" cy="246221"/>
                <a:chOff x="5012337" y="1527831"/>
                <a:chExt cx="1196040" cy="246221"/>
              </a:xfrm>
            </p:grpSpPr>
            <p:sp>
              <p:nvSpPr>
                <p:cNvPr id="8" name="Right Arrow 7"/>
                <p:cNvSpPr/>
                <p:nvPr/>
              </p:nvSpPr>
              <p:spPr>
                <a:xfrm rot="10800000">
                  <a:off x="5012337" y="1546882"/>
                  <a:ext cx="1196040" cy="195900"/>
                </a:xfrm>
                <a:prstGeom prst="rightArrow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5316848" y="1527831"/>
                  <a:ext cx="60305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GTAS</a:t>
                  </a:r>
                </a:p>
              </p:txBody>
            </p:sp>
          </p:grpSp>
          <p:sp>
            <p:nvSpPr>
              <p:cNvPr id="7" name="Right Arrow 6"/>
              <p:cNvSpPr/>
              <p:nvPr/>
            </p:nvSpPr>
            <p:spPr>
              <a:xfrm>
                <a:off x="4244344" y="1518306"/>
                <a:ext cx="106355" cy="3122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533400" y="1052096"/>
              <a:ext cx="4138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1095375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47" name="Group 46"/>
          <p:cNvGrpSpPr/>
          <p:nvPr/>
        </p:nvGrpSpPr>
        <p:grpSpPr>
          <a:xfrm>
            <a:off x="3143250" y="2895064"/>
            <a:ext cx="2038350" cy="2068806"/>
            <a:chOff x="1695450" y="2895064"/>
            <a:chExt cx="2038350" cy="2068806"/>
          </a:xfrm>
        </p:grpSpPr>
        <p:grpSp>
          <p:nvGrpSpPr>
            <p:cNvPr id="34" name="Group 33"/>
            <p:cNvGrpSpPr/>
            <p:nvPr/>
          </p:nvGrpSpPr>
          <p:grpSpPr>
            <a:xfrm>
              <a:off x="2314783" y="2895064"/>
              <a:ext cx="1419017" cy="2068806"/>
              <a:chOff x="8270753" y="361132"/>
              <a:chExt cx="1419017" cy="2068806"/>
            </a:xfrm>
          </p:grpSpPr>
          <p:graphicFrame>
            <p:nvGraphicFramePr>
              <p:cNvPr id="35" name="Object 3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72790747"/>
                  </p:ext>
                </p:extLst>
              </p:nvPr>
            </p:nvGraphicFramePr>
            <p:xfrm>
              <a:off x="8270753" y="1232905"/>
              <a:ext cx="1419017" cy="119703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81" name="Image" r:id="rId3" imgW="801360" imgH="676440" progId="Photoshop.Image.12">
                      <p:embed/>
                    </p:oleObj>
                  </mc:Choice>
                  <mc:Fallback>
                    <p:oleObj name="Image" r:id="rId3" imgW="801360" imgH="67644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8270753" y="1232905"/>
                            <a:ext cx="1419017" cy="119703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6" name="TextBox 35"/>
              <p:cNvSpPr txBox="1"/>
              <p:nvPr/>
            </p:nvSpPr>
            <p:spPr>
              <a:xfrm rot="16200000">
                <a:off x="7952243" y="738882"/>
                <a:ext cx="9060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 ladder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>
                <a:off x="8215618" y="730411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8480146" y="713472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8829730" y="781205"/>
                <a:ext cx="8274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AS.4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9060140" y="747328"/>
                <a:ext cx="8915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AS.81</a:t>
                </a:r>
              </a:p>
            </p:txBody>
          </p:sp>
        </p:grpSp>
        <p:cxnSp>
          <p:nvCxnSpPr>
            <p:cNvPr id="43" name="Straight Arrow Connector 42"/>
            <p:cNvCxnSpPr/>
            <p:nvPr/>
          </p:nvCxnSpPr>
          <p:spPr>
            <a:xfrm>
              <a:off x="2136202" y="4324350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1695450" y="4191000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9 Kb</a:t>
              </a:r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666751" y="5524500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(A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GT Antisense RNA construct indicating the position of the primers (small black arrow) (Primer name: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Na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SGTA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AS transgene (899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 and 5).</a:t>
            </a:r>
          </a:p>
        </p:txBody>
      </p:sp>
    </p:spTree>
    <p:extLst>
      <p:ext uri="{BB962C8B-B14F-4D97-AF65-F5344CB8AC3E}">
        <p14:creationId xmlns:p14="http://schemas.microsoft.com/office/powerpoint/2010/main" val="3397346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/>
          <p:cNvGrpSpPr/>
          <p:nvPr/>
        </p:nvGrpSpPr>
        <p:grpSpPr>
          <a:xfrm>
            <a:off x="695405" y="1715529"/>
            <a:ext cx="7219870" cy="341871"/>
            <a:chOff x="695405" y="1715529"/>
            <a:chExt cx="7219870" cy="341871"/>
          </a:xfrm>
        </p:grpSpPr>
        <p:grpSp>
          <p:nvGrpSpPr>
            <p:cNvPr id="43" name="Group 42"/>
            <p:cNvGrpSpPr/>
            <p:nvPr/>
          </p:nvGrpSpPr>
          <p:grpSpPr>
            <a:xfrm>
              <a:off x="5061616" y="1726476"/>
              <a:ext cx="1880238" cy="330924"/>
              <a:chOff x="4057583" y="2496103"/>
              <a:chExt cx="1880238" cy="330924"/>
            </a:xfrm>
          </p:grpSpPr>
          <p:grpSp>
            <p:nvGrpSpPr>
              <p:cNvPr id="68" name="Group 67"/>
              <p:cNvGrpSpPr/>
              <p:nvPr/>
            </p:nvGrpSpPr>
            <p:grpSpPr>
              <a:xfrm>
                <a:off x="4057583" y="2496103"/>
                <a:ext cx="1880238" cy="330924"/>
                <a:chOff x="4057581" y="2489215"/>
                <a:chExt cx="1483313" cy="257442"/>
              </a:xfrm>
            </p:grpSpPr>
            <p:grpSp>
              <p:nvGrpSpPr>
                <p:cNvPr id="70" name="Group 69"/>
                <p:cNvGrpSpPr/>
                <p:nvPr/>
              </p:nvGrpSpPr>
              <p:grpSpPr>
                <a:xfrm>
                  <a:off x="4057581" y="2489215"/>
                  <a:ext cx="484191" cy="246221"/>
                  <a:chOff x="4057581" y="2489215"/>
                  <a:chExt cx="484191" cy="246221"/>
                </a:xfrm>
              </p:grpSpPr>
              <p:sp>
                <p:nvSpPr>
                  <p:cNvPr id="77" name="Right Arrow 76"/>
                  <p:cNvSpPr/>
                  <p:nvPr/>
                </p:nvSpPr>
                <p:spPr>
                  <a:xfrm>
                    <a:off x="4057581" y="2514610"/>
                    <a:ext cx="484191" cy="152400"/>
                  </a:xfrm>
                  <a:prstGeom prst="rightArrow">
                    <a:avLst/>
                  </a:prstGeom>
                  <a:solidFill>
                    <a:schemeClr val="bg2">
                      <a:lumMod val="50000"/>
                    </a:schemeClr>
                  </a:solidFill>
                  <a:ln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4138938" y="2489215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S</a:t>
                    </a:r>
                  </a:p>
                </p:txBody>
              </p:sp>
            </p:grpSp>
            <p:grpSp>
              <p:nvGrpSpPr>
                <p:cNvPr id="71" name="Group 70"/>
                <p:cNvGrpSpPr/>
                <p:nvPr/>
              </p:nvGrpSpPr>
              <p:grpSpPr>
                <a:xfrm>
                  <a:off x="5053738" y="2500436"/>
                  <a:ext cx="487156" cy="246221"/>
                  <a:chOff x="5053738" y="2500436"/>
                  <a:chExt cx="487156" cy="246221"/>
                </a:xfrm>
              </p:grpSpPr>
              <p:sp>
                <p:nvSpPr>
                  <p:cNvPr id="75" name="Right Arrow 74"/>
                  <p:cNvSpPr/>
                  <p:nvPr/>
                </p:nvSpPr>
                <p:spPr>
                  <a:xfrm rot="10800000">
                    <a:off x="5053738" y="2518421"/>
                    <a:ext cx="484191" cy="152400"/>
                  </a:xfrm>
                  <a:prstGeom prst="rightArrow">
                    <a:avLst/>
                  </a:prstGeom>
                  <a:solidFill>
                    <a:schemeClr val="bg2">
                      <a:lumMod val="50000"/>
                    </a:schemeClr>
                  </a:solidFill>
                  <a:ln>
                    <a:solidFill>
                      <a:schemeClr val="bg2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5192722" y="2500436"/>
                    <a:ext cx="34817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S</a:t>
                    </a:r>
                  </a:p>
                </p:txBody>
              </p:sp>
            </p:grpSp>
            <p:grpSp>
              <p:nvGrpSpPr>
                <p:cNvPr id="72" name="Group 71"/>
                <p:cNvGrpSpPr/>
                <p:nvPr/>
              </p:nvGrpSpPr>
              <p:grpSpPr>
                <a:xfrm>
                  <a:off x="4572000" y="2494722"/>
                  <a:ext cx="457200" cy="246221"/>
                  <a:chOff x="4572000" y="2494722"/>
                  <a:chExt cx="457200" cy="246221"/>
                </a:xfrm>
              </p:grpSpPr>
              <p:sp>
                <p:nvSpPr>
                  <p:cNvPr id="73" name="Rectangle 72"/>
                  <p:cNvSpPr/>
                  <p:nvPr/>
                </p:nvSpPr>
                <p:spPr>
                  <a:xfrm>
                    <a:off x="4572000" y="2544250"/>
                    <a:ext cx="457200" cy="101526"/>
                  </a:xfrm>
                  <a:prstGeom prst="rect">
                    <a:avLst/>
                  </a:prstGeom>
                  <a:solidFill>
                    <a:schemeClr val="accent2">
                      <a:lumMod val="40000"/>
                      <a:lumOff val="60000"/>
                    </a:schemeClr>
                  </a:solidFill>
                  <a:ln>
                    <a:solidFill>
                      <a:schemeClr val="accent2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4693204" y="2494722"/>
                    <a:ext cx="32733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N</a:t>
                    </a:r>
                  </a:p>
                </p:txBody>
              </p:sp>
            </p:grpSp>
          </p:grpSp>
          <p:sp>
            <p:nvSpPr>
              <p:cNvPr id="69" name="Right Arrow 68"/>
              <p:cNvSpPr/>
              <p:nvPr/>
            </p:nvSpPr>
            <p:spPr>
              <a:xfrm>
                <a:off x="4718937" y="2508523"/>
                <a:ext cx="106355" cy="3122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695405" y="1715529"/>
              <a:ext cx="4341447" cy="294789"/>
              <a:chOff x="1095110" y="1488309"/>
              <a:chExt cx="4341447" cy="294789"/>
            </a:xfrm>
          </p:grpSpPr>
          <p:sp>
            <p:nvSpPr>
              <p:cNvPr id="53" name="Rectangle 52"/>
              <p:cNvSpPr/>
              <p:nvPr/>
            </p:nvSpPr>
            <p:spPr>
              <a:xfrm>
                <a:off x="1095110" y="1525312"/>
                <a:ext cx="365760" cy="22860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4" name="Rounded Rectangle 53"/>
              <p:cNvSpPr/>
              <p:nvPr/>
            </p:nvSpPr>
            <p:spPr>
              <a:xfrm>
                <a:off x="1484209" y="1525311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2442828" y="1528034"/>
                <a:ext cx="1097280" cy="228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Right Arrow 55"/>
              <p:cNvSpPr/>
              <p:nvPr/>
            </p:nvSpPr>
            <p:spPr>
              <a:xfrm flipH="1">
                <a:off x="3561474" y="1528237"/>
                <a:ext cx="457200" cy="228600"/>
              </a:xfrm>
              <a:prstGeom prst="rightArrow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Right Arrow 56"/>
              <p:cNvSpPr/>
              <p:nvPr/>
            </p:nvSpPr>
            <p:spPr>
              <a:xfrm rot="10800000" flipH="1">
                <a:off x="4705037" y="1525311"/>
                <a:ext cx="731520" cy="228600"/>
              </a:xfrm>
              <a:prstGeom prst="rightArrow">
                <a:avLst/>
              </a:prstGeom>
              <a:solidFill>
                <a:srgbClr val="97517B"/>
              </a:solidFill>
              <a:ln>
                <a:solidFill>
                  <a:srgbClr val="9751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095110" y="1506099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>
                <a:off x="4393138" y="1644110"/>
                <a:ext cx="297269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60" name="TextBox 59"/>
              <p:cNvSpPr txBox="1"/>
              <p:nvPr/>
            </p:nvSpPr>
            <p:spPr>
              <a:xfrm>
                <a:off x="1441410" y="1502212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1872325" y="1522396"/>
                <a:ext cx="548640" cy="2286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857935" y="148830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csp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2800341" y="149637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634067" y="1506099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</a:t>
                </a:r>
              </a:p>
            </p:txBody>
          </p:sp>
          <p:sp>
            <p:nvSpPr>
              <p:cNvPr id="65" name="Rounded Rectangle 64"/>
              <p:cNvSpPr/>
              <p:nvPr/>
            </p:nvSpPr>
            <p:spPr>
              <a:xfrm>
                <a:off x="4027378" y="1528237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992137" y="1504894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4815629" y="1505896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pin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6960683" y="1716748"/>
              <a:ext cx="954592" cy="295025"/>
              <a:chOff x="6799023" y="1499053"/>
              <a:chExt cx="954592" cy="295025"/>
            </a:xfrm>
          </p:grpSpPr>
          <p:grpSp>
            <p:nvGrpSpPr>
              <p:cNvPr id="47" name="Group 46"/>
              <p:cNvGrpSpPr/>
              <p:nvPr/>
            </p:nvGrpSpPr>
            <p:grpSpPr>
              <a:xfrm>
                <a:off x="6799023" y="1528237"/>
                <a:ext cx="925516" cy="228600"/>
                <a:chOff x="6783784" y="1528237"/>
                <a:chExt cx="925516" cy="228600"/>
              </a:xfrm>
            </p:grpSpPr>
            <p:sp>
              <p:nvSpPr>
                <p:cNvPr id="51" name="Rectangle 50"/>
                <p:cNvSpPr/>
                <p:nvPr/>
              </p:nvSpPr>
              <p:spPr>
                <a:xfrm>
                  <a:off x="6783784" y="1528237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2" name="Rectangle 51"/>
                <p:cNvSpPr/>
                <p:nvPr/>
              </p:nvSpPr>
              <p:spPr>
                <a:xfrm>
                  <a:off x="7343540" y="1528237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48" name="Group 47"/>
              <p:cNvGrpSpPr/>
              <p:nvPr/>
            </p:nvGrpSpPr>
            <p:grpSpPr>
              <a:xfrm>
                <a:off x="6819875" y="1499053"/>
                <a:ext cx="933740" cy="295025"/>
                <a:chOff x="6766536" y="1499053"/>
                <a:chExt cx="933740" cy="295025"/>
              </a:xfrm>
            </p:grpSpPr>
            <p:sp>
              <p:nvSpPr>
                <p:cNvPr id="49" name="TextBox 48"/>
                <p:cNvSpPr txBox="1"/>
                <p:nvPr/>
              </p:nvSpPr>
              <p:spPr>
                <a:xfrm>
                  <a:off x="6766536" y="1499053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7302410" y="1517079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</a:p>
              </p:txBody>
            </p:sp>
          </p:grpSp>
        </p:grpSp>
        <p:sp>
          <p:nvSpPr>
            <p:cNvPr id="46" name="Right Arrow 45"/>
            <p:cNvSpPr/>
            <p:nvPr/>
          </p:nvSpPr>
          <p:spPr>
            <a:xfrm flipH="1">
              <a:off x="7387510" y="2010691"/>
              <a:ext cx="108680" cy="457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533401" y="468868"/>
            <a:ext cx="7239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      SGT RNAi construct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533400" y="10520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33400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933700" y="3005998"/>
            <a:ext cx="2233705" cy="2156840"/>
            <a:chOff x="2933700" y="3005998"/>
            <a:chExt cx="2233705" cy="2156840"/>
          </a:xfrm>
        </p:grpSpPr>
        <p:grpSp>
          <p:nvGrpSpPr>
            <p:cNvPr id="42" name="Group 41"/>
            <p:cNvGrpSpPr/>
            <p:nvPr/>
          </p:nvGrpSpPr>
          <p:grpSpPr>
            <a:xfrm>
              <a:off x="3552825" y="3005998"/>
              <a:ext cx="1614580" cy="2156840"/>
              <a:chOff x="9958558" y="273099"/>
              <a:chExt cx="1614580" cy="2156840"/>
            </a:xfrm>
          </p:grpSpPr>
          <p:graphicFrame>
            <p:nvGraphicFramePr>
              <p:cNvPr id="83" name="Object 8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64112147"/>
                  </p:ext>
                </p:extLst>
              </p:nvPr>
            </p:nvGraphicFramePr>
            <p:xfrm>
              <a:off x="9958558" y="1232905"/>
              <a:ext cx="1614580" cy="119703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03" name="Image" r:id="rId3" imgW="847080" imgH="514800" progId="Photoshop.Image.12">
                      <p:embed/>
                    </p:oleObj>
                  </mc:Choice>
                  <mc:Fallback>
                    <p:oleObj name="Image" r:id="rId3" imgW="847080" imgH="51480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9958558" y="1232905"/>
                            <a:ext cx="1614580" cy="119703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4" name="TextBox 83"/>
              <p:cNvSpPr txBox="1"/>
              <p:nvPr/>
            </p:nvSpPr>
            <p:spPr>
              <a:xfrm rot="16200000">
                <a:off x="9730244" y="747347"/>
                <a:ext cx="9060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 ladder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9985157" y="719826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 rot="16200000">
                <a:off x="10283549" y="713470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6200000">
                <a:off x="10534192" y="671136"/>
                <a:ext cx="10422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RNAi.17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10839012" y="671125"/>
                <a:ext cx="104227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RNAi.26</a:t>
                </a:r>
              </a:p>
            </p:txBody>
          </p:sp>
        </p:grpSp>
        <p:cxnSp>
          <p:nvCxnSpPr>
            <p:cNvPr id="90" name="Straight Arrow Connector 89"/>
            <p:cNvCxnSpPr/>
            <p:nvPr/>
          </p:nvCxnSpPr>
          <p:spPr>
            <a:xfrm>
              <a:off x="3374452" y="4362450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2933700" y="4229100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 Kb</a:t>
              </a:r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666751" y="5524500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(B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GT RNAi indicating the position of the primers (small black arrow) (Primer name: Intron-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spA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 RNAi transgene (732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 and 5).</a:t>
            </a:r>
          </a:p>
        </p:txBody>
      </p:sp>
    </p:spTree>
    <p:extLst>
      <p:ext uri="{BB962C8B-B14F-4D97-AF65-F5344CB8AC3E}">
        <p14:creationId xmlns:p14="http://schemas.microsoft.com/office/powerpoint/2010/main" val="3170918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62865" y="1640319"/>
            <a:ext cx="6557135" cy="340881"/>
            <a:chOff x="640123" y="1488309"/>
            <a:chExt cx="6557135" cy="340881"/>
          </a:xfrm>
        </p:grpSpPr>
        <p:grpSp>
          <p:nvGrpSpPr>
            <p:cNvPr id="3" name="Group 2"/>
            <p:cNvGrpSpPr/>
            <p:nvPr/>
          </p:nvGrpSpPr>
          <p:grpSpPr>
            <a:xfrm>
              <a:off x="640123" y="1488309"/>
              <a:ext cx="4341447" cy="294789"/>
              <a:chOff x="1095110" y="1488309"/>
              <a:chExt cx="4341447" cy="294789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1095110" y="1525312"/>
                <a:ext cx="365760" cy="22860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1484209" y="1525311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442828" y="1528034"/>
                <a:ext cx="1097280" cy="228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ight Arrow 18"/>
              <p:cNvSpPr/>
              <p:nvPr/>
            </p:nvSpPr>
            <p:spPr>
              <a:xfrm flipH="1">
                <a:off x="3561474" y="1528237"/>
                <a:ext cx="457200" cy="228600"/>
              </a:xfrm>
              <a:prstGeom prst="rightArrow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ight Arrow 19"/>
              <p:cNvSpPr/>
              <p:nvPr/>
            </p:nvSpPr>
            <p:spPr>
              <a:xfrm rot="10800000" flipH="1">
                <a:off x="4705037" y="1525311"/>
                <a:ext cx="731520" cy="228600"/>
              </a:xfrm>
              <a:prstGeom prst="rightArrow">
                <a:avLst/>
              </a:prstGeom>
              <a:solidFill>
                <a:srgbClr val="97517B"/>
              </a:solidFill>
              <a:ln>
                <a:solidFill>
                  <a:srgbClr val="9751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095110" y="1506099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4393138" y="1644110"/>
                <a:ext cx="297269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1441410" y="1502212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1872325" y="1522396"/>
                <a:ext cx="548640" cy="2286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857935" y="148830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csp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800341" y="149637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634067" y="1506099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</a:t>
                </a:r>
              </a:p>
            </p:txBody>
          </p:sp>
          <p:sp>
            <p:nvSpPr>
              <p:cNvPr id="28" name="Rounded Rectangle 27"/>
              <p:cNvSpPr/>
              <p:nvPr/>
            </p:nvSpPr>
            <p:spPr>
              <a:xfrm>
                <a:off x="4027378" y="1528237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992137" y="1504894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815629" y="1505896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pin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242666" y="1499053"/>
              <a:ext cx="954592" cy="295025"/>
              <a:chOff x="6799023" y="1499053"/>
              <a:chExt cx="954592" cy="295025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6799023" y="1528237"/>
                <a:ext cx="925516" cy="228600"/>
                <a:chOff x="6783784" y="1528237"/>
                <a:chExt cx="925516" cy="228600"/>
              </a:xfrm>
            </p:grpSpPr>
            <p:sp>
              <p:nvSpPr>
                <p:cNvPr id="14" name="Rectangle 13"/>
                <p:cNvSpPr/>
                <p:nvPr/>
              </p:nvSpPr>
              <p:spPr>
                <a:xfrm>
                  <a:off x="6783784" y="1528237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7343540" y="1528237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6819875" y="1499053"/>
                <a:ext cx="933740" cy="295025"/>
                <a:chOff x="6766536" y="1499053"/>
                <a:chExt cx="933740" cy="295025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6766536" y="1499053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7302410" y="1517079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</a:p>
              </p:txBody>
            </p:sp>
          </p:grpSp>
        </p:grpSp>
        <p:grpSp>
          <p:nvGrpSpPr>
            <p:cNvPr id="5" name="Group 4"/>
            <p:cNvGrpSpPr/>
            <p:nvPr/>
          </p:nvGrpSpPr>
          <p:grpSpPr>
            <a:xfrm rot="10800000">
              <a:off x="4928231" y="1518306"/>
              <a:ext cx="1275034" cy="246221"/>
              <a:chOff x="5012337" y="1518307"/>
              <a:chExt cx="1275034" cy="246221"/>
            </a:xfrm>
          </p:grpSpPr>
          <p:sp>
            <p:nvSpPr>
              <p:cNvPr id="8" name="Right Arrow 7"/>
              <p:cNvSpPr/>
              <p:nvPr/>
            </p:nvSpPr>
            <p:spPr>
              <a:xfrm rot="10800000">
                <a:off x="5012337" y="1546882"/>
                <a:ext cx="1196040" cy="195900"/>
              </a:xfrm>
              <a:prstGeom prst="rightArrow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0800000">
                <a:off x="5201817" y="1518307"/>
                <a:ext cx="108555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TamiRNA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40</a:t>
                </a:r>
              </a:p>
            </p:txBody>
          </p:sp>
        </p:grpSp>
        <p:sp>
          <p:nvSpPr>
            <p:cNvPr id="6" name="Right Arrow 5"/>
            <p:cNvSpPr/>
            <p:nvPr/>
          </p:nvSpPr>
          <p:spPr>
            <a:xfrm>
              <a:off x="4272919" y="1508781"/>
              <a:ext cx="106355" cy="31227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Arrow 6"/>
            <p:cNvSpPr/>
            <p:nvPr/>
          </p:nvSpPr>
          <p:spPr>
            <a:xfrm flipH="1">
              <a:off x="6655953" y="1783471"/>
              <a:ext cx="108680" cy="457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666751" y="468868"/>
            <a:ext cx="7414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    SGTamiRNA40 construct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33400" y="10520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33400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45" name="Group 44"/>
          <p:cNvGrpSpPr/>
          <p:nvPr/>
        </p:nvGrpSpPr>
        <p:grpSpPr>
          <a:xfrm>
            <a:off x="2819400" y="2667000"/>
            <a:ext cx="1894672" cy="2261787"/>
            <a:chOff x="2819400" y="2667000"/>
            <a:chExt cx="1894672" cy="2261787"/>
          </a:xfrm>
        </p:grpSpPr>
        <p:grpSp>
          <p:nvGrpSpPr>
            <p:cNvPr id="34" name="Group 33"/>
            <p:cNvGrpSpPr/>
            <p:nvPr/>
          </p:nvGrpSpPr>
          <p:grpSpPr>
            <a:xfrm>
              <a:off x="3429000" y="2667000"/>
              <a:ext cx="1285072" cy="2261787"/>
              <a:chOff x="3862528" y="173863"/>
              <a:chExt cx="1285072" cy="2261787"/>
            </a:xfrm>
          </p:grpSpPr>
          <p:graphicFrame>
            <p:nvGraphicFramePr>
              <p:cNvPr id="35" name="Object 3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89403881"/>
                  </p:ext>
                </p:extLst>
              </p:nvPr>
            </p:nvGraphicFramePr>
            <p:xfrm>
              <a:off x="3870855" y="1236663"/>
              <a:ext cx="1276745" cy="11989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19" name="Image" r:id="rId3" imgW="807480" imgH="758880" progId="Photoshop.Image.12">
                      <p:embed/>
                    </p:oleObj>
                  </mc:Choice>
                  <mc:Fallback>
                    <p:oleObj name="Image" r:id="rId3" imgW="807480" imgH="75888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870855" y="1236663"/>
                            <a:ext cx="1276745" cy="11989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6" name="TextBox 35"/>
              <p:cNvSpPr txBox="1"/>
              <p:nvPr/>
            </p:nvSpPr>
            <p:spPr>
              <a:xfrm rot="16200000">
                <a:off x="3532630" y="747351"/>
                <a:ext cx="9060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 ladder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6200000">
                <a:off x="3770604" y="738880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3984330" y="721941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4201667" y="628801"/>
                <a:ext cx="109196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amiR40.3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4415143" y="628795"/>
                <a:ext cx="11560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GTamiR40.35</a:t>
                </a:r>
              </a:p>
            </p:txBody>
          </p:sp>
        </p:grpSp>
        <p:cxnSp>
          <p:nvCxnSpPr>
            <p:cNvPr id="42" name="Straight Arrow Connector 41"/>
            <p:cNvCxnSpPr/>
            <p:nvPr/>
          </p:nvCxnSpPr>
          <p:spPr>
            <a:xfrm>
              <a:off x="3260152" y="4267200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2819400" y="4133850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 Kb</a:t>
              </a:r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666751" y="5524500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(C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GT amiR40 constructs indicating the position of the primers (small black arrow) (Primer name: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Na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spA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AS transgene (750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 and 5).</a:t>
            </a:r>
          </a:p>
        </p:txBody>
      </p:sp>
    </p:spTree>
    <p:extLst>
      <p:ext uri="{BB962C8B-B14F-4D97-AF65-F5344CB8AC3E}">
        <p14:creationId xmlns:p14="http://schemas.microsoft.com/office/powerpoint/2010/main" val="11372244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39065" y="1716519"/>
            <a:ext cx="6557135" cy="340881"/>
            <a:chOff x="640123" y="1488309"/>
            <a:chExt cx="6557135" cy="340881"/>
          </a:xfrm>
        </p:grpSpPr>
        <p:grpSp>
          <p:nvGrpSpPr>
            <p:cNvPr id="3" name="Group 2"/>
            <p:cNvGrpSpPr/>
            <p:nvPr/>
          </p:nvGrpSpPr>
          <p:grpSpPr>
            <a:xfrm>
              <a:off x="640123" y="1488309"/>
              <a:ext cx="4341447" cy="294789"/>
              <a:chOff x="1095110" y="1488309"/>
              <a:chExt cx="4341447" cy="294789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1095110" y="1525312"/>
                <a:ext cx="365760" cy="22860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1484209" y="1525311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442828" y="1528034"/>
                <a:ext cx="1097280" cy="228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ight Arrow 18"/>
              <p:cNvSpPr/>
              <p:nvPr/>
            </p:nvSpPr>
            <p:spPr>
              <a:xfrm flipH="1">
                <a:off x="3561474" y="1528237"/>
                <a:ext cx="457200" cy="228600"/>
              </a:xfrm>
              <a:prstGeom prst="rightArrow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ight Arrow 19"/>
              <p:cNvSpPr/>
              <p:nvPr/>
            </p:nvSpPr>
            <p:spPr>
              <a:xfrm rot="10800000" flipH="1">
                <a:off x="4705037" y="1525311"/>
                <a:ext cx="731520" cy="228600"/>
              </a:xfrm>
              <a:prstGeom prst="rightArrow">
                <a:avLst/>
              </a:prstGeom>
              <a:solidFill>
                <a:srgbClr val="97517B"/>
              </a:solidFill>
              <a:ln>
                <a:solidFill>
                  <a:srgbClr val="9751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095110" y="1506099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4393138" y="1644110"/>
                <a:ext cx="297269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1441410" y="1502212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1872325" y="1522396"/>
                <a:ext cx="548640" cy="2286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857935" y="148830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csp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800341" y="149637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634067" y="1506099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</a:t>
                </a:r>
              </a:p>
            </p:txBody>
          </p:sp>
          <p:sp>
            <p:nvSpPr>
              <p:cNvPr id="28" name="Rounded Rectangle 27"/>
              <p:cNvSpPr/>
              <p:nvPr/>
            </p:nvSpPr>
            <p:spPr>
              <a:xfrm>
                <a:off x="4027378" y="1528237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992137" y="1504894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768004" y="149637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TEp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242666" y="1499053"/>
              <a:ext cx="954592" cy="295025"/>
              <a:chOff x="6799023" y="1499053"/>
              <a:chExt cx="954592" cy="295025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6799023" y="1528237"/>
                <a:ext cx="925516" cy="228600"/>
                <a:chOff x="6783784" y="1528237"/>
                <a:chExt cx="925516" cy="228600"/>
              </a:xfrm>
            </p:grpSpPr>
            <p:sp>
              <p:nvSpPr>
                <p:cNvPr id="14" name="Rectangle 13"/>
                <p:cNvSpPr/>
                <p:nvPr/>
              </p:nvSpPr>
              <p:spPr>
                <a:xfrm>
                  <a:off x="6783784" y="1528237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7343540" y="1528237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6819875" y="1499053"/>
                <a:ext cx="933740" cy="295025"/>
                <a:chOff x="6766536" y="1499053"/>
                <a:chExt cx="933740" cy="295025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6766536" y="1499053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7302410" y="1517079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</a:p>
              </p:txBody>
            </p:sp>
          </p:grpSp>
        </p:grpSp>
        <p:grpSp>
          <p:nvGrpSpPr>
            <p:cNvPr id="5" name="Group 4"/>
            <p:cNvGrpSpPr/>
            <p:nvPr/>
          </p:nvGrpSpPr>
          <p:grpSpPr>
            <a:xfrm>
              <a:off x="5012337" y="1527831"/>
              <a:ext cx="1196040" cy="246221"/>
              <a:chOff x="5012337" y="1527831"/>
              <a:chExt cx="1196040" cy="246221"/>
            </a:xfrm>
          </p:grpSpPr>
          <p:sp>
            <p:nvSpPr>
              <p:cNvPr id="8" name="Right Arrow 7"/>
              <p:cNvSpPr/>
              <p:nvPr/>
            </p:nvSpPr>
            <p:spPr>
              <a:xfrm rot="10800000">
                <a:off x="5012337" y="1546882"/>
                <a:ext cx="1196040" cy="195900"/>
              </a:xfrm>
              <a:prstGeom prst="rightArrow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316848" y="1527831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TAS</a:t>
                </a:r>
              </a:p>
            </p:txBody>
          </p:sp>
        </p:grpSp>
        <p:sp>
          <p:nvSpPr>
            <p:cNvPr id="6" name="Right Arrow 5"/>
            <p:cNvSpPr/>
            <p:nvPr/>
          </p:nvSpPr>
          <p:spPr>
            <a:xfrm>
              <a:off x="4272919" y="1508781"/>
              <a:ext cx="106355" cy="31227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Arrow 6"/>
            <p:cNvSpPr/>
            <p:nvPr/>
          </p:nvSpPr>
          <p:spPr>
            <a:xfrm flipH="1">
              <a:off x="6655953" y="1783471"/>
              <a:ext cx="108680" cy="457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740348" y="468868"/>
            <a:ext cx="7486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  SCT Antisense RNA construct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33400" y="10520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33400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666751" y="5708303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 (D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CT Antisense constructs indicating the position of the primers (small black arrow) (Primer name: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SCT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P- 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spA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AS transgene (2352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 and 5).</a:t>
            </a:r>
          </a:p>
        </p:txBody>
      </p:sp>
      <p:grpSp>
        <p:nvGrpSpPr>
          <p:cNvPr id="45" name="Group 44"/>
          <p:cNvGrpSpPr/>
          <p:nvPr/>
        </p:nvGrpSpPr>
        <p:grpSpPr>
          <a:xfrm>
            <a:off x="2667000" y="2667000"/>
            <a:ext cx="2144184" cy="2924477"/>
            <a:chOff x="2667000" y="2667000"/>
            <a:chExt cx="2144184" cy="2924477"/>
          </a:xfrm>
        </p:grpSpPr>
        <p:grpSp>
          <p:nvGrpSpPr>
            <p:cNvPr id="34" name="Group 33"/>
            <p:cNvGrpSpPr/>
            <p:nvPr/>
          </p:nvGrpSpPr>
          <p:grpSpPr>
            <a:xfrm>
              <a:off x="3276600" y="2667000"/>
              <a:ext cx="1534584" cy="2924477"/>
              <a:chOff x="1818217" y="3127624"/>
              <a:chExt cx="1534584" cy="2924477"/>
            </a:xfrm>
          </p:grpSpPr>
          <p:graphicFrame>
            <p:nvGraphicFramePr>
              <p:cNvPr id="35" name="Object 3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402228342"/>
                  </p:ext>
                </p:extLst>
              </p:nvPr>
            </p:nvGraphicFramePr>
            <p:xfrm>
              <a:off x="1818217" y="4004733"/>
              <a:ext cx="1534584" cy="204736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142" name="Image" r:id="rId3" imgW="645840" imgH="862560" progId="Photoshop.Image.12">
                      <p:embed/>
                    </p:oleObj>
                  </mc:Choice>
                  <mc:Fallback>
                    <p:oleObj name="Image" r:id="rId3" imgW="645840" imgH="86256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818217" y="4004733"/>
                            <a:ext cx="1534584" cy="204736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7" name="TextBox 36"/>
              <p:cNvSpPr txBox="1"/>
              <p:nvPr/>
            </p:nvSpPr>
            <p:spPr>
              <a:xfrm rot="16200000">
                <a:off x="1520058" y="3497965"/>
                <a:ext cx="9348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Kb ladder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1797860" y="3497961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2130121" y="3479964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2482911" y="3558275"/>
                <a:ext cx="8210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AS.8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2755652" y="3524404"/>
                <a:ext cx="8851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AS.36</a:t>
                </a:r>
              </a:p>
            </p:txBody>
          </p:sp>
        </p:grpSp>
        <p:cxnSp>
          <p:nvCxnSpPr>
            <p:cNvPr id="43" name="Straight Arrow Connector 42"/>
            <p:cNvCxnSpPr/>
            <p:nvPr/>
          </p:nvCxnSpPr>
          <p:spPr>
            <a:xfrm>
              <a:off x="3107752" y="4487704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2667000" y="4354354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0 K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791183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27816" y="1782204"/>
            <a:ext cx="7225584" cy="351396"/>
            <a:chOff x="640123" y="1488309"/>
            <a:chExt cx="7225584" cy="351396"/>
          </a:xfrm>
        </p:grpSpPr>
        <p:grpSp>
          <p:nvGrpSpPr>
            <p:cNvPr id="3" name="Group 2"/>
            <p:cNvGrpSpPr/>
            <p:nvPr/>
          </p:nvGrpSpPr>
          <p:grpSpPr>
            <a:xfrm>
              <a:off x="640123" y="1488309"/>
              <a:ext cx="4341447" cy="294789"/>
              <a:chOff x="1095110" y="1488309"/>
              <a:chExt cx="4341447" cy="294789"/>
            </a:xfrm>
          </p:grpSpPr>
          <p:sp>
            <p:nvSpPr>
              <p:cNvPr id="24" name="Rectangle 23"/>
              <p:cNvSpPr/>
              <p:nvPr/>
            </p:nvSpPr>
            <p:spPr>
              <a:xfrm>
                <a:off x="1095110" y="1525312"/>
                <a:ext cx="365760" cy="22860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Rounded Rectangle 24"/>
              <p:cNvSpPr/>
              <p:nvPr/>
            </p:nvSpPr>
            <p:spPr>
              <a:xfrm>
                <a:off x="1484209" y="1525311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2442828" y="1518509"/>
                <a:ext cx="1097280" cy="228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ight Arrow 26"/>
              <p:cNvSpPr/>
              <p:nvPr/>
            </p:nvSpPr>
            <p:spPr>
              <a:xfrm flipH="1">
                <a:off x="3561474" y="1528237"/>
                <a:ext cx="457200" cy="228600"/>
              </a:xfrm>
              <a:prstGeom prst="rightArrow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Right Arrow 27"/>
              <p:cNvSpPr/>
              <p:nvPr/>
            </p:nvSpPr>
            <p:spPr>
              <a:xfrm rot="10800000" flipH="1">
                <a:off x="4705037" y="1525311"/>
                <a:ext cx="731520" cy="228600"/>
              </a:xfrm>
              <a:prstGeom prst="rightArrow">
                <a:avLst/>
              </a:prstGeom>
              <a:solidFill>
                <a:srgbClr val="97517B"/>
              </a:solidFill>
              <a:ln>
                <a:solidFill>
                  <a:srgbClr val="9751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095110" y="1506099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4393138" y="1644110"/>
                <a:ext cx="297269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1441410" y="1502212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1872325" y="1522396"/>
                <a:ext cx="548640" cy="2286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857935" y="148830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csp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800341" y="149637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3634067" y="1506099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</a:t>
                </a:r>
              </a:p>
            </p:txBody>
          </p:sp>
          <p:sp>
            <p:nvSpPr>
              <p:cNvPr id="36" name="Rounded Rectangle 35"/>
              <p:cNvSpPr/>
              <p:nvPr/>
            </p:nvSpPr>
            <p:spPr>
              <a:xfrm>
                <a:off x="4027378" y="1528237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992137" y="1504894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768004" y="149637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TEp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911115" y="1499053"/>
              <a:ext cx="954592" cy="295025"/>
              <a:chOff x="6799023" y="1499053"/>
              <a:chExt cx="954592" cy="295025"/>
            </a:xfrm>
          </p:grpSpPr>
          <p:grpSp>
            <p:nvGrpSpPr>
              <p:cNvPr id="18" name="Group 17"/>
              <p:cNvGrpSpPr/>
              <p:nvPr/>
            </p:nvGrpSpPr>
            <p:grpSpPr>
              <a:xfrm>
                <a:off x="6799023" y="1528237"/>
                <a:ext cx="925516" cy="228600"/>
                <a:chOff x="6783784" y="1528237"/>
                <a:chExt cx="925516" cy="228600"/>
              </a:xfrm>
            </p:grpSpPr>
            <p:sp>
              <p:nvSpPr>
                <p:cNvPr id="22" name="Rectangle 21"/>
                <p:cNvSpPr/>
                <p:nvPr/>
              </p:nvSpPr>
              <p:spPr>
                <a:xfrm>
                  <a:off x="6783784" y="1528237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7343540" y="1528237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9" name="Group 18"/>
              <p:cNvGrpSpPr/>
              <p:nvPr/>
            </p:nvGrpSpPr>
            <p:grpSpPr>
              <a:xfrm>
                <a:off x="6819875" y="1499053"/>
                <a:ext cx="933740" cy="295025"/>
                <a:chOff x="6766536" y="1499053"/>
                <a:chExt cx="933740" cy="295025"/>
              </a:xfrm>
            </p:grpSpPr>
            <p:sp>
              <p:nvSpPr>
                <p:cNvPr id="20" name="TextBox 19"/>
                <p:cNvSpPr txBox="1"/>
                <p:nvPr/>
              </p:nvSpPr>
              <p:spPr>
                <a:xfrm>
                  <a:off x="6766536" y="1499053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7302410" y="1517079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</a:p>
              </p:txBody>
            </p:sp>
          </p:grpSp>
        </p:grpSp>
        <p:grpSp>
          <p:nvGrpSpPr>
            <p:cNvPr id="5" name="Group 4"/>
            <p:cNvGrpSpPr/>
            <p:nvPr/>
          </p:nvGrpSpPr>
          <p:grpSpPr>
            <a:xfrm>
              <a:off x="5006334" y="1508781"/>
              <a:ext cx="1880238" cy="330924"/>
              <a:chOff x="4057583" y="2496103"/>
              <a:chExt cx="1880238" cy="330924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4057583" y="2496103"/>
                <a:ext cx="1880238" cy="330924"/>
                <a:chOff x="4057581" y="2489215"/>
                <a:chExt cx="1483313" cy="257442"/>
              </a:xfrm>
            </p:grpSpPr>
            <p:grpSp>
              <p:nvGrpSpPr>
                <p:cNvPr id="9" name="Group 8"/>
                <p:cNvGrpSpPr/>
                <p:nvPr/>
              </p:nvGrpSpPr>
              <p:grpSpPr>
                <a:xfrm>
                  <a:off x="4057581" y="2489215"/>
                  <a:ext cx="484191" cy="246221"/>
                  <a:chOff x="4057581" y="2489215"/>
                  <a:chExt cx="484191" cy="246221"/>
                </a:xfrm>
              </p:grpSpPr>
              <p:sp>
                <p:nvSpPr>
                  <p:cNvPr id="16" name="Right Arrow 15"/>
                  <p:cNvSpPr/>
                  <p:nvPr/>
                </p:nvSpPr>
                <p:spPr>
                  <a:xfrm>
                    <a:off x="4057581" y="2514610"/>
                    <a:ext cx="484191" cy="152400"/>
                  </a:xfrm>
                  <a:prstGeom prst="rightArrow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>
                    <a:solidFill>
                      <a:schemeClr val="accent1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4138938" y="2489215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S</a:t>
                    </a:r>
                  </a:p>
                </p:txBody>
              </p:sp>
            </p:grpSp>
            <p:grpSp>
              <p:nvGrpSpPr>
                <p:cNvPr id="10" name="Group 9"/>
                <p:cNvGrpSpPr/>
                <p:nvPr/>
              </p:nvGrpSpPr>
              <p:grpSpPr>
                <a:xfrm>
                  <a:off x="5053738" y="2500436"/>
                  <a:ext cx="487156" cy="246221"/>
                  <a:chOff x="5053738" y="2500436"/>
                  <a:chExt cx="487156" cy="246221"/>
                </a:xfrm>
              </p:grpSpPr>
              <p:sp>
                <p:nvSpPr>
                  <p:cNvPr id="14" name="Right Arrow 13"/>
                  <p:cNvSpPr/>
                  <p:nvPr/>
                </p:nvSpPr>
                <p:spPr>
                  <a:xfrm rot="10800000">
                    <a:off x="5053738" y="2518421"/>
                    <a:ext cx="484191" cy="152400"/>
                  </a:xfrm>
                  <a:prstGeom prst="rightArrow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>
                    <a:solidFill>
                      <a:schemeClr val="accent1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5192722" y="2500436"/>
                    <a:ext cx="34817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S</a:t>
                    </a:r>
                  </a:p>
                </p:txBody>
              </p:sp>
            </p:grpSp>
            <p:grpSp>
              <p:nvGrpSpPr>
                <p:cNvPr id="11" name="Group 10"/>
                <p:cNvGrpSpPr/>
                <p:nvPr/>
              </p:nvGrpSpPr>
              <p:grpSpPr>
                <a:xfrm>
                  <a:off x="4572000" y="2494722"/>
                  <a:ext cx="457200" cy="246221"/>
                  <a:chOff x="4572000" y="2494722"/>
                  <a:chExt cx="457200" cy="246221"/>
                </a:xfrm>
              </p:grpSpPr>
              <p:sp>
                <p:nvSpPr>
                  <p:cNvPr id="12" name="Rectangle 11"/>
                  <p:cNvSpPr/>
                  <p:nvPr/>
                </p:nvSpPr>
                <p:spPr>
                  <a:xfrm>
                    <a:off x="4572000" y="2544250"/>
                    <a:ext cx="457200" cy="101526"/>
                  </a:xfrm>
                  <a:prstGeom prst="rect">
                    <a:avLst/>
                  </a:prstGeom>
                  <a:solidFill>
                    <a:schemeClr val="bg2">
                      <a:lumMod val="75000"/>
                    </a:schemeClr>
                  </a:solidFill>
                  <a:ln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4693204" y="2494722"/>
                    <a:ext cx="32733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N</a:t>
                    </a:r>
                  </a:p>
                </p:txBody>
              </p:sp>
            </p:grpSp>
          </p:grpSp>
          <p:sp>
            <p:nvSpPr>
              <p:cNvPr id="7" name="Right Arrow 6"/>
              <p:cNvSpPr/>
              <p:nvPr/>
            </p:nvSpPr>
            <p:spPr>
              <a:xfrm>
                <a:off x="4110994" y="2508523"/>
                <a:ext cx="106355" cy="3122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ight Arrow 7"/>
              <p:cNvSpPr/>
              <p:nvPr/>
            </p:nvSpPr>
            <p:spPr>
              <a:xfrm flipH="1">
                <a:off x="5185307" y="2726063"/>
                <a:ext cx="108680" cy="45719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9" name="TextBox 38"/>
          <p:cNvSpPr txBox="1"/>
          <p:nvPr/>
        </p:nvSpPr>
        <p:spPr>
          <a:xfrm>
            <a:off x="609600" y="468868"/>
            <a:ext cx="68622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   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TRNAi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truct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33400" y="10520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33400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2981325" y="2743200"/>
            <a:ext cx="2242820" cy="2153634"/>
            <a:chOff x="2981325" y="2743200"/>
            <a:chExt cx="2242820" cy="2153634"/>
          </a:xfrm>
        </p:grpSpPr>
        <p:grpSp>
          <p:nvGrpSpPr>
            <p:cNvPr id="42" name="Group 41"/>
            <p:cNvGrpSpPr/>
            <p:nvPr/>
          </p:nvGrpSpPr>
          <p:grpSpPr>
            <a:xfrm>
              <a:off x="3596718" y="2743200"/>
              <a:ext cx="1627427" cy="2153634"/>
              <a:chOff x="6382257" y="284774"/>
              <a:chExt cx="1627427" cy="2153634"/>
            </a:xfrm>
          </p:grpSpPr>
          <p:graphicFrame>
            <p:nvGraphicFramePr>
              <p:cNvPr id="43" name="Object 4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25712309"/>
                  </p:ext>
                </p:extLst>
              </p:nvPr>
            </p:nvGraphicFramePr>
            <p:xfrm>
              <a:off x="6382257" y="1232906"/>
              <a:ext cx="1627427" cy="120550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65" name="Image" r:id="rId3" imgW="813600" imgH="603360" progId="Photoshop.Image.12">
                      <p:embed/>
                    </p:oleObj>
                  </mc:Choice>
                  <mc:Fallback>
                    <p:oleObj name="Image" r:id="rId3" imgW="813600" imgH="60336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6382257" y="1232906"/>
                            <a:ext cx="1627427" cy="120550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4" name="TextBox 43"/>
              <p:cNvSpPr txBox="1"/>
              <p:nvPr/>
            </p:nvSpPr>
            <p:spPr>
              <a:xfrm rot="16200000">
                <a:off x="6131900" y="747350"/>
                <a:ext cx="9060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 ladder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6200000">
                <a:off x="6395275" y="730412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6727536" y="721940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7021919" y="721932"/>
                <a:ext cx="9717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RNAi.1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6200000">
                <a:off x="7311594" y="679594"/>
                <a:ext cx="10358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RNAi.36</a:t>
                </a:r>
              </a:p>
            </p:txBody>
          </p:sp>
        </p:grpSp>
        <p:cxnSp>
          <p:nvCxnSpPr>
            <p:cNvPr id="50" name="Straight Arrow Connector 49"/>
            <p:cNvCxnSpPr/>
            <p:nvPr/>
          </p:nvCxnSpPr>
          <p:spPr>
            <a:xfrm>
              <a:off x="3431602" y="4621054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981325" y="4487704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 Kb</a:t>
              </a: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666751" y="5486400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 (E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CT RNAi constructs indicating the position of the primers (small black arrow) (Primer name: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SCTRNAi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SCT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AS transgene (560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and 5).</a:t>
            </a:r>
          </a:p>
        </p:txBody>
      </p:sp>
    </p:spTree>
    <p:extLst>
      <p:ext uri="{BB962C8B-B14F-4D97-AF65-F5344CB8AC3E}">
        <p14:creationId xmlns:p14="http://schemas.microsoft.com/office/powerpoint/2010/main" val="11909342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86665" y="1716519"/>
            <a:ext cx="6557135" cy="340881"/>
            <a:chOff x="640123" y="1488309"/>
            <a:chExt cx="6557135" cy="340881"/>
          </a:xfrm>
        </p:grpSpPr>
        <p:grpSp>
          <p:nvGrpSpPr>
            <p:cNvPr id="3" name="Group 2"/>
            <p:cNvGrpSpPr/>
            <p:nvPr/>
          </p:nvGrpSpPr>
          <p:grpSpPr>
            <a:xfrm>
              <a:off x="640123" y="1488309"/>
              <a:ext cx="4341447" cy="294789"/>
              <a:chOff x="1095110" y="1488309"/>
              <a:chExt cx="4341447" cy="294789"/>
            </a:xfrm>
          </p:grpSpPr>
          <p:sp>
            <p:nvSpPr>
              <p:cNvPr id="16" name="Rectangle 15"/>
              <p:cNvSpPr/>
              <p:nvPr/>
            </p:nvSpPr>
            <p:spPr>
              <a:xfrm>
                <a:off x="1095110" y="1525312"/>
                <a:ext cx="365760" cy="228600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1484209" y="1525311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442828" y="1528034"/>
                <a:ext cx="1097280" cy="228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ight Arrow 18"/>
              <p:cNvSpPr/>
              <p:nvPr/>
            </p:nvSpPr>
            <p:spPr>
              <a:xfrm flipH="1">
                <a:off x="3561474" y="1528237"/>
                <a:ext cx="457200" cy="228600"/>
              </a:xfrm>
              <a:prstGeom prst="rightArrow">
                <a:avLst/>
              </a:prstGeom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ight Arrow 19"/>
              <p:cNvSpPr/>
              <p:nvPr/>
            </p:nvSpPr>
            <p:spPr>
              <a:xfrm rot="10800000" flipH="1">
                <a:off x="4705037" y="1525311"/>
                <a:ext cx="731520" cy="228600"/>
              </a:xfrm>
              <a:prstGeom prst="rightArrow">
                <a:avLst/>
              </a:prstGeom>
              <a:solidFill>
                <a:srgbClr val="97517B"/>
              </a:solidFill>
              <a:ln>
                <a:solidFill>
                  <a:srgbClr val="9751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095110" y="1506099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4393138" y="1644110"/>
                <a:ext cx="297269" cy="0"/>
              </a:xfrm>
              <a:prstGeom prst="line">
                <a:avLst/>
              </a:prstGeom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sp>
            <p:nvSpPr>
              <p:cNvPr id="23" name="TextBox 22"/>
              <p:cNvSpPr txBox="1"/>
              <p:nvPr/>
            </p:nvSpPr>
            <p:spPr>
              <a:xfrm>
                <a:off x="1441410" y="1502212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1872325" y="1522396"/>
                <a:ext cx="548640" cy="228600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857935" y="1488309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cspA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800341" y="1496371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634067" y="1506099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</a:t>
                </a:r>
              </a:p>
            </p:txBody>
          </p:sp>
          <p:sp>
            <p:nvSpPr>
              <p:cNvPr id="28" name="Rounded Rectangle 27"/>
              <p:cNvSpPr/>
              <p:nvPr/>
            </p:nvSpPr>
            <p:spPr>
              <a:xfrm>
                <a:off x="4027378" y="1528237"/>
                <a:ext cx="365760" cy="228600"/>
              </a:xfrm>
              <a:prstGeom prst="round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992137" y="1504894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P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768004" y="149637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TEp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242666" y="1499053"/>
              <a:ext cx="954592" cy="295025"/>
              <a:chOff x="6799023" y="1499053"/>
              <a:chExt cx="954592" cy="295025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6799023" y="1528237"/>
                <a:ext cx="925516" cy="228600"/>
                <a:chOff x="6783784" y="1528237"/>
                <a:chExt cx="925516" cy="228600"/>
              </a:xfrm>
            </p:grpSpPr>
            <p:sp>
              <p:nvSpPr>
                <p:cNvPr id="14" name="Rectangle 13"/>
                <p:cNvSpPr/>
                <p:nvPr/>
              </p:nvSpPr>
              <p:spPr>
                <a:xfrm>
                  <a:off x="6783784" y="1528237"/>
                  <a:ext cx="548640" cy="228600"/>
                </a:xfrm>
                <a:prstGeom prst="rect">
                  <a:avLst/>
                </a:prstGeom>
                <a:solidFill>
                  <a:schemeClr val="accent3">
                    <a:lumMod val="40000"/>
                    <a:lumOff val="60000"/>
                  </a:schemeClr>
                </a:solidFill>
                <a:ln>
                  <a:solidFill>
                    <a:schemeClr val="accent3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7343540" y="1528237"/>
                  <a:ext cx="365760" cy="228600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6819875" y="1499053"/>
                <a:ext cx="933740" cy="295025"/>
                <a:chOff x="6766536" y="1499053"/>
                <a:chExt cx="933740" cy="295025"/>
              </a:xfrm>
            </p:grpSpPr>
            <p:sp>
              <p:nvSpPr>
                <p:cNvPr id="12" name="TextBox 11"/>
                <p:cNvSpPr txBox="1"/>
                <p:nvPr/>
              </p:nvSpPr>
              <p:spPr>
                <a:xfrm>
                  <a:off x="6766536" y="1499053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cspA</a:t>
                  </a:r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7302410" y="1517079"/>
                  <a:ext cx="3978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B</a:t>
                  </a:r>
                </a:p>
              </p:txBody>
            </p:sp>
          </p:grpSp>
        </p:grpSp>
        <p:grpSp>
          <p:nvGrpSpPr>
            <p:cNvPr id="5" name="Group 4"/>
            <p:cNvGrpSpPr/>
            <p:nvPr/>
          </p:nvGrpSpPr>
          <p:grpSpPr>
            <a:xfrm rot="10800000">
              <a:off x="4937756" y="1508782"/>
              <a:ext cx="1265509" cy="246221"/>
              <a:chOff x="5012337" y="1527831"/>
              <a:chExt cx="1265509" cy="246221"/>
            </a:xfrm>
          </p:grpSpPr>
          <p:sp>
            <p:nvSpPr>
              <p:cNvPr id="8" name="Right Arrow 7"/>
              <p:cNvSpPr/>
              <p:nvPr/>
            </p:nvSpPr>
            <p:spPr>
              <a:xfrm rot="10800000">
                <a:off x="5012337" y="1546882"/>
                <a:ext cx="1196040" cy="195900"/>
              </a:xfrm>
              <a:prstGeom prst="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0800000">
                <a:off x="5198704" y="1527831"/>
                <a:ext cx="10791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TamiRNA</a:t>
                </a:r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37</a:t>
                </a:r>
              </a:p>
            </p:txBody>
          </p:sp>
        </p:grpSp>
        <p:sp>
          <p:nvSpPr>
            <p:cNvPr id="6" name="Right Arrow 5"/>
            <p:cNvSpPr/>
            <p:nvPr/>
          </p:nvSpPr>
          <p:spPr>
            <a:xfrm>
              <a:off x="4272919" y="1508781"/>
              <a:ext cx="106355" cy="31227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Arrow 6"/>
            <p:cNvSpPr/>
            <p:nvPr/>
          </p:nvSpPr>
          <p:spPr>
            <a:xfrm flipH="1">
              <a:off x="6655953" y="1783471"/>
              <a:ext cx="108680" cy="45719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1" name="TextBox 30"/>
          <p:cNvSpPr txBox="1"/>
          <p:nvPr/>
        </p:nvSpPr>
        <p:spPr>
          <a:xfrm>
            <a:off x="533400" y="468868"/>
            <a:ext cx="7624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   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TamiRNA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7 construct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33400" y="10520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33400" y="2633246"/>
            <a:ext cx="4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2828925" y="2838357"/>
            <a:ext cx="2134659" cy="2267043"/>
            <a:chOff x="2828925" y="2514600"/>
            <a:chExt cx="2134659" cy="2267043"/>
          </a:xfrm>
        </p:grpSpPr>
        <p:grpSp>
          <p:nvGrpSpPr>
            <p:cNvPr id="42" name="Group 41"/>
            <p:cNvGrpSpPr/>
            <p:nvPr/>
          </p:nvGrpSpPr>
          <p:grpSpPr>
            <a:xfrm>
              <a:off x="3429000" y="2514600"/>
              <a:ext cx="1534584" cy="2267043"/>
              <a:chOff x="1818217" y="168607"/>
              <a:chExt cx="1534584" cy="2267043"/>
            </a:xfrm>
          </p:grpSpPr>
          <p:graphicFrame>
            <p:nvGraphicFramePr>
              <p:cNvPr id="43" name="Object 4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15643617"/>
                  </p:ext>
                </p:extLst>
              </p:nvPr>
            </p:nvGraphicFramePr>
            <p:xfrm>
              <a:off x="1818217" y="1236663"/>
              <a:ext cx="1534584" cy="11989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186" name="Image" r:id="rId3" imgW="798480" imgH="624600" progId="Photoshop.Image.12">
                      <p:embed/>
                    </p:oleObj>
                  </mc:Choice>
                  <mc:Fallback>
                    <p:oleObj name="Image" r:id="rId3" imgW="798480" imgH="624600" progId="Photoshop.Image.12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818217" y="1236663"/>
                            <a:ext cx="1534584" cy="11989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5" name="TextBox 44"/>
              <p:cNvSpPr txBox="1"/>
              <p:nvPr/>
            </p:nvSpPr>
            <p:spPr>
              <a:xfrm rot="16200000">
                <a:off x="1551424" y="747356"/>
                <a:ext cx="9060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 ladder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1831733" y="738885"/>
                <a:ext cx="9380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ary vector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2096258" y="721946"/>
                <a:ext cx="95090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una (host)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6200000">
                <a:off x="2301676" y="620342"/>
                <a:ext cx="11496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amiR37.56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 rot="16200000">
                <a:off x="2606480" y="620333"/>
                <a:ext cx="11496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jSCTamiR37.56</a:t>
                </a:r>
              </a:p>
            </p:txBody>
          </p:sp>
        </p:grpSp>
        <p:cxnSp>
          <p:nvCxnSpPr>
            <p:cNvPr id="50" name="Straight Arrow Connector 49"/>
            <p:cNvCxnSpPr/>
            <p:nvPr/>
          </p:nvCxnSpPr>
          <p:spPr>
            <a:xfrm>
              <a:off x="3269677" y="4095750"/>
              <a:ext cx="16884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828925" y="3962400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 Kb</a:t>
              </a: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666751" y="5524500"/>
            <a:ext cx="78486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 (F).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p of the SCT amiR37 constructs indicating the position of the primers (small black arrow) (Primer name: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jSCT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P- F;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spA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; </a:t>
            </a:r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Table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ed for the transgene amplification. (b) Amplification of the SGTAS transgene (1122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) from the binary vector (Lane 2) and genomic DNA of the  two representative T</a:t>
            </a:r>
            <a:r>
              <a:rPr lang="en-US" sz="13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genics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ane 4 and 5).</a:t>
            </a:r>
          </a:p>
        </p:txBody>
      </p:sp>
    </p:spTree>
    <p:extLst>
      <p:ext uri="{BB962C8B-B14F-4D97-AF65-F5344CB8AC3E}">
        <p14:creationId xmlns:p14="http://schemas.microsoft.com/office/powerpoint/2010/main" val="2451165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3</TotalTime>
  <Words>682</Words>
  <Application>Microsoft Office PowerPoint</Application>
  <PresentationFormat>On-screen Show (4:3)</PresentationFormat>
  <Paragraphs>124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in Kajla</dc:creator>
  <cp:lastModifiedBy>Sachin Kajla</cp:lastModifiedBy>
  <cp:revision>42</cp:revision>
  <dcterms:created xsi:type="dcterms:W3CDTF">2017-05-03T11:38:40Z</dcterms:created>
  <dcterms:modified xsi:type="dcterms:W3CDTF">2017-07-03T12:01:37Z</dcterms:modified>
</cp:coreProperties>
</file>